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56" r:id="rId3"/>
    <p:sldId id="270" r:id="rId4"/>
    <p:sldId id="257" r:id="rId5"/>
    <p:sldId id="258" r:id="rId6"/>
    <p:sldId id="259" r:id="rId7"/>
    <p:sldId id="260" r:id="rId8"/>
    <p:sldId id="261" r:id="rId9"/>
    <p:sldId id="262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4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D05C8B-FEB7-95CE-8957-7F46CF0F75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42A1DCC-A8FC-2BE8-DBEB-4BC31B113C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FC9D5C6-CCDA-5CAC-3D64-6F077E512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E0AE5-DE88-4F18-956E-C31099B490EB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79F0C5-89E5-3C37-87C5-411CAB145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B29B51B-FA05-1DF9-32BD-768A74C60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5D47A-4F42-406E-9521-D092B82761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7559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61937D7-EF0E-4704-BD1B-D476AD1668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B87F955-6653-8A08-BE9C-464DD0F8F5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20BC2C7-CDC6-267B-63B6-FEC24C7FE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E0AE5-DE88-4F18-956E-C31099B490EB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BF5F058-364E-4693-5298-E9F0E11A3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3B60EC-4A96-4953-9BF8-AB9ECECE0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5D47A-4F42-406E-9521-D092B82761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4276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BECEC72-4E3E-C639-CF4B-D203537C08E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1132653-A947-9FB3-99A9-56F67F6996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EE927DB-2F2E-957F-2754-A2E93A1DF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E0AE5-DE88-4F18-956E-C31099B490EB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5B500CC-5E6D-9145-2FE0-DDFD76A3B0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ED3904-2163-3B85-4058-488C300D5F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5D47A-4F42-406E-9521-D092B82761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6607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561A57-C9A8-8A2E-E997-374E1E0436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24AE00A-9D29-3030-57E1-96A26865A8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58307FB-5779-F78B-F4D9-60DC41B4C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E0AE5-DE88-4F18-956E-C31099B490EB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309E0A-1E57-00FA-2A6D-CCCA0155AB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CCBFA79-47DC-1C55-C92D-894FA65ECF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5D47A-4F42-406E-9521-D092B82761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5242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F09C53-07E4-9DC5-90B6-9354D5C3ED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DE0C5EE-48C7-781E-ACD7-2F460ED362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163ED2-065A-8F24-07A2-D6D1B90B5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E0AE5-DE88-4F18-956E-C31099B490EB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515AD4-AF59-2554-C4E8-07D5F6A1FA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C59928-6458-6AF4-46A7-939729EC19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5D47A-4F42-406E-9521-D092B82761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1671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CCB36F-543B-CE4A-EA1A-5C75599FD3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A213BDC-32F6-95D5-5200-C655639B77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71E6C0B-6692-695A-C514-0B4662F750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C11C72B-8A21-4C6E-E849-6C3A1801C4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E0AE5-DE88-4F18-956E-C31099B490EB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A954D46-D35A-87D4-696B-DE1D869D95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1B4E50A-63C3-5A32-FCD7-23F087C9B4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5D47A-4F42-406E-9521-D092B82761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4205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352FF7-B7F6-3095-BD10-1EA30F2450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D4B3B14-A010-685F-06EA-65C2F47B9A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E1FB96E-8B5E-3681-A1D6-8F302F50DF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656B068-E4FD-7A1A-02C4-F05B67A699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4484E4D-86E3-686D-F6E5-F6872F8BA3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1228539-F6B4-C1E6-1ADD-DA319EC69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E0AE5-DE88-4F18-956E-C31099B490EB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27AC50C-2EA3-4A45-D6CF-2C942DE4B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BD89F7E-2B0B-7300-9CC5-D5FC92DDAA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5D47A-4F42-406E-9521-D092B82761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5554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EAF06F-D64A-A064-4242-E9D5ED09FE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9A3C8D6-8CB7-5955-ECAA-00A2CC42A2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E0AE5-DE88-4F18-956E-C31099B490EB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D2FFB4F-0F47-B0C8-5875-D4C44DC2A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4E7C73C-F23B-0D50-5661-B747C7C40B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5D47A-4F42-406E-9521-D092B82761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3696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D1F042D-88D0-F45E-1BED-F2C6DBEFB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E0AE5-DE88-4F18-956E-C31099B490EB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8654392-8699-CABA-2BB8-08A0C7238D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49563FE-3816-3B4F-5E20-E94CBE2963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5D47A-4F42-406E-9521-D092B82761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82525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83281E-7056-C2B3-75CE-C2457D6390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847FF3F-6F43-38EB-C207-94EC700684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C9F4F34-0E53-6FA0-5304-5C8B5E902E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5D6C4F6-DD9F-4795-C7FA-CA89EC7CD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E0AE5-DE88-4F18-956E-C31099B490EB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7F2B9BA-CFEC-25F6-3486-399D1A2B08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7769BFE-03DC-289D-7430-4149CA96D2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5D47A-4F42-406E-9521-D092B82761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497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F62D28-B74D-624F-2382-7D479C4FEB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E50FCA6-9EE8-DB06-E15E-56E7F12478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91A71E3-1FB5-D829-48CA-481040EBEB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0C53E5C-9C7B-529B-0A9F-3CD619C2E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E0AE5-DE88-4F18-956E-C31099B490EB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E140928-0A7E-2E1E-9A6E-4D6DEFB096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368AF24-A622-D46E-8C2C-2AB12960E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5D47A-4F42-406E-9521-D092B82761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2088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8B1598E-1CC5-C3C2-93E7-3653DE65FA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00BCE0C-7B8F-E904-2FB5-946754958C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2997BDC-FC2C-3A16-E3FE-769FB0BB73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DE0AE5-DE88-4F18-956E-C31099B490EB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B342503-A148-2556-8A80-A2148C11E3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B29DD0E-C25D-A1A4-87A9-84A54202B5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A5D47A-4F42-406E-9521-D092B82761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2991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14F6131C-7331-2C73-3DBC-C20028B606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7113" y="0"/>
            <a:ext cx="8378462" cy="6306532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1D71A97D-41B3-5DDB-F40A-6B861910F7A4}"/>
              </a:ext>
            </a:extLst>
          </p:cNvPr>
          <p:cNvSpPr txBox="1"/>
          <p:nvPr/>
        </p:nvSpPr>
        <p:spPr>
          <a:xfrm>
            <a:off x="6796975" y="4147794"/>
            <a:ext cx="2158738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CD7BB9CF-54EA-C8D8-7B99-837813FE1EB1}"/>
              </a:ext>
            </a:extLst>
          </p:cNvPr>
          <p:cNvSpPr txBox="1"/>
          <p:nvPr/>
        </p:nvSpPr>
        <p:spPr>
          <a:xfrm>
            <a:off x="6656895" y="3187948"/>
            <a:ext cx="234727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2600FE4-5296-E045-6B26-DD0742D43646}"/>
              </a:ext>
            </a:extLst>
          </p:cNvPr>
          <p:cNvSpPr txBox="1"/>
          <p:nvPr/>
        </p:nvSpPr>
        <p:spPr>
          <a:xfrm>
            <a:off x="289875" y="433880"/>
            <a:ext cx="2884602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picture shows COL1A1 and β-actin, the molecular weight of COL1A1 is 130kDA, and the molecular weight of β-actin is 42kDA. Figure 4-F is displaye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81189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8DB0EB25-17B7-9EE9-12DA-F6EF80B333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2870" y="0"/>
            <a:ext cx="9107424" cy="68580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0C157DDD-A4DE-7225-9C47-C82291076FD7}"/>
              </a:ext>
            </a:extLst>
          </p:cNvPr>
          <p:cNvSpPr txBox="1"/>
          <p:nvPr/>
        </p:nvSpPr>
        <p:spPr>
          <a:xfrm>
            <a:off x="5571241" y="867266"/>
            <a:ext cx="214931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0E77DB9-9EBC-214C-B711-008B429AF78B}"/>
              </a:ext>
            </a:extLst>
          </p:cNvPr>
          <p:cNvSpPr txBox="1"/>
          <p:nvPr/>
        </p:nvSpPr>
        <p:spPr>
          <a:xfrm>
            <a:off x="5571241" y="1800520"/>
            <a:ext cx="214931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A692C2F-6207-2061-BCF7-DA21D7F669C0}"/>
              </a:ext>
            </a:extLst>
          </p:cNvPr>
          <p:cNvSpPr txBox="1"/>
          <p:nvPr/>
        </p:nvSpPr>
        <p:spPr>
          <a:xfrm>
            <a:off x="289875" y="433880"/>
            <a:ext cx="2884602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picture shows COL1A1 and β-actin, the molecular weight of COL1A1 is 130kDA, and the molecular weight of β-actin is 42kDA. Figure 5-F is displaye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36629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F7FE30DC-9CEC-059E-8507-2B410A6E54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1187620"/>
            <a:ext cx="5229129" cy="3936005"/>
          </a:xfrm>
          <a:prstGeom prst="rect">
            <a:avLst/>
          </a:prstGeom>
          <a:ln>
            <a:solidFill>
              <a:srgbClr val="FF0000"/>
            </a:solidFill>
          </a:ln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DB35B754-DCD5-EFEF-6B10-DBB6D5AD8228}"/>
              </a:ext>
            </a:extLst>
          </p:cNvPr>
          <p:cNvSpPr txBox="1"/>
          <p:nvPr/>
        </p:nvSpPr>
        <p:spPr>
          <a:xfrm>
            <a:off x="7937369" y="2281287"/>
            <a:ext cx="1046376" cy="3582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AECD1A55-6AEE-3BDB-3658-4DFB6C9B9C15}"/>
              </a:ext>
            </a:extLst>
          </p:cNvPr>
          <p:cNvSpPr txBox="1"/>
          <p:nvPr/>
        </p:nvSpPr>
        <p:spPr>
          <a:xfrm>
            <a:off x="289875" y="433880"/>
            <a:ext cx="288460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picture shows weight of β-actin is 42kDA. Figure 4-F is displaye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06342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3EDD32C-551F-AAED-772F-E0CA294E43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2873" y="1296233"/>
            <a:ext cx="5065776" cy="381304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F0878CA-7476-1C58-2466-F04F9478D3D8}"/>
              </a:ext>
            </a:extLst>
          </p:cNvPr>
          <p:cNvSpPr txBox="1"/>
          <p:nvPr/>
        </p:nvSpPr>
        <p:spPr>
          <a:xfrm>
            <a:off x="8616099" y="2714920"/>
            <a:ext cx="102752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0A14A9AC-FA2A-F0D1-708C-EF224EC17D41}"/>
              </a:ext>
            </a:extLst>
          </p:cNvPr>
          <p:cNvSpPr txBox="1"/>
          <p:nvPr/>
        </p:nvSpPr>
        <p:spPr>
          <a:xfrm>
            <a:off x="289875" y="433880"/>
            <a:ext cx="288460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picture shows weight of α-SMA is 45kDA. Figure 4-F is displaye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94266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195E6238-6ABF-2EE0-2D35-BC388BC58E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9257" y="195878"/>
            <a:ext cx="7936634" cy="5973965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3BF41CB9-C5B5-067D-1157-1B80F492FF76}"/>
              </a:ext>
            </a:extLst>
          </p:cNvPr>
          <p:cNvSpPr txBox="1"/>
          <p:nvPr/>
        </p:nvSpPr>
        <p:spPr>
          <a:xfrm>
            <a:off x="7748833" y="1970202"/>
            <a:ext cx="1234911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1026F3E-733F-5777-10D8-335B451BF091}"/>
              </a:ext>
            </a:extLst>
          </p:cNvPr>
          <p:cNvSpPr txBox="1"/>
          <p:nvPr/>
        </p:nvSpPr>
        <p:spPr>
          <a:xfrm>
            <a:off x="289875" y="433880"/>
            <a:ext cx="288460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picture shows weight of α-SMA is 45kDA. Figure 5-F is displaye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09528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74A8B17-729A-015C-614B-059B96F2CA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7837" y="1305659"/>
            <a:ext cx="5065776" cy="3813048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ECD138A-99EE-14CF-105D-07787DCB9B51}"/>
              </a:ext>
            </a:extLst>
          </p:cNvPr>
          <p:cNvSpPr txBox="1"/>
          <p:nvPr/>
        </p:nvSpPr>
        <p:spPr>
          <a:xfrm>
            <a:off x="7682845" y="2092751"/>
            <a:ext cx="886120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5F1A7DF-9062-86BC-36EB-43668DE6CCA7}"/>
              </a:ext>
            </a:extLst>
          </p:cNvPr>
          <p:cNvSpPr txBox="1"/>
          <p:nvPr/>
        </p:nvSpPr>
        <p:spPr>
          <a:xfrm>
            <a:off x="289875" y="433880"/>
            <a:ext cx="288460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picture shows weight of β-actin is 42kDA. Figure 5-F is displaye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49460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14137440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12822419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83352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08</Words>
  <Application>Microsoft Office PowerPoint</Application>
  <PresentationFormat>宽屏</PresentationFormat>
  <Paragraphs>6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4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艳玲 程</dc:creator>
  <cp:lastModifiedBy>艳玲 程</cp:lastModifiedBy>
  <cp:revision>2</cp:revision>
  <dcterms:created xsi:type="dcterms:W3CDTF">2024-11-25T12:48:11Z</dcterms:created>
  <dcterms:modified xsi:type="dcterms:W3CDTF">2024-11-25T13:04:28Z</dcterms:modified>
</cp:coreProperties>
</file>